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0E3FDE45-AF77-4B5C-9715-49D594BDF05E}" styleName="Light Style 1 - Accent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104" y="66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409FF-B849-468A-8750-F9ECAE837558}" type="datetimeFigureOut">
              <a:rPr lang="en-GB" smtClean="0"/>
              <a:t>16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67309-227E-4202-97B5-6466362CF1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54730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409FF-B849-468A-8750-F9ECAE837558}" type="datetimeFigureOut">
              <a:rPr lang="en-GB" smtClean="0"/>
              <a:t>16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67309-227E-4202-97B5-6466362CF1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13783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409FF-B849-468A-8750-F9ECAE837558}" type="datetimeFigureOut">
              <a:rPr lang="en-GB" smtClean="0"/>
              <a:t>16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67309-227E-4202-97B5-6466362CF1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7752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409FF-B849-468A-8750-F9ECAE837558}" type="datetimeFigureOut">
              <a:rPr lang="en-GB" smtClean="0"/>
              <a:t>16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67309-227E-4202-97B5-6466362CF1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74484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409FF-B849-468A-8750-F9ECAE837558}" type="datetimeFigureOut">
              <a:rPr lang="en-GB" smtClean="0"/>
              <a:t>16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67309-227E-4202-97B5-6466362CF1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57695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409FF-B849-468A-8750-F9ECAE837558}" type="datetimeFigureOut">
              <a:rPr lang="en-GB" smtClean="0"/>
              <a:t>16/10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67309-227E-4202-97B5-6466362CF1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84823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409FF-B849-468A-8750-F9ECAE837558}" type="datetimeFigureOut">
              <a:rPr lang="en-GB" smtClean="0"/>
              <a:t>16/10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67309-227E-4202-97B5-6466362CF1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0747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409FF-B849-468A-8750-F9ECAE837558}" type="datetimeFigureOut">
              <a:rPr lang="en-GB" smtClean="0"/>
              <a:t>16/10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67309-227E-4202-97B5-6466362CF1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05944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409FF-B849-468A-8750-F9ECAE837558}" type="datetimeFigureOut">
              <a:rPr lang="en-GB" smtClean="0"/>
              <a:t>16/10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67309-227E-4202-97B5-6466362CF1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4605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409FF-B849-468A-8750-F9ECAE837558}" type="datetimeFigureOut">
              <a:rPr lang="en-GB" smtClean="0"/>
              <a:t>16/10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67309-227E-4202-97B5-6466362CF1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41840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409FF-B849-468A-8750-F9ECAE837558}" type="datetimeFigureOut">
              <a:rPr lang="en-GB" smtClean="0"/>
              <a:t>16/10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67309-227E-4202-97B5-6466362CF1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51065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1409FF-B849-468A-8750-F9ECAE837558}" type="datetimeFigureOut">
              <a:rPr lang="en-GB" smtClean="0"/>
              <a:t>16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F67309-227E-4202-97B5-6466362CF1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97058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260648" y="5364088"/>
            <a:ext cx="621069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uberculin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kin test responses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kin test thickness in mm for Sham and HAV vaccinated animals 35 weeks post- MAP challenge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algn="just"/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  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rease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skin thickness from day 0 to day 3. </a:t>
            </a:r>
            <a:endParaRPr lang="en-GB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gnificant differences between groups were noted (</a:t>
            </a:r>
            <a:r>
              <a:rPr lang="en-GB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 0.523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All animals were classed as non-reactors according to the standard interpretation of the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st as previously </a:t>
            </a:r>
            <a:r>
              <a:rPr lang="en-GB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scribed </a:t>
            </a:r>
            <a:r>
              <a:rPr lang="en-GB" sz="120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[49].</a:t>
            </a:r>
            <a:endParaRPr lang="en-GB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3" name="Table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84180716"/>
              </p:ext>
            </p:extLst>
          </p:nvPr>
        </p:nvGraphicFramePr>
        <p:xfrm>
          <a:off x="332656" y="748377"/>
          <a:ext cx="6172204" cy="4475648"/>
        </p:xfrm>
        <a:graphic>
          <a:graphicData uri="http://schemas.openxmlformats.org/drawingml/2006/table">
            <a:tbl>
              <a:tblPr firstRow="1" firstCol="1" bandRow="1"/>
              <a:tblGrid>
                <a:gridCol w="492136"/>
                <a:gridCol w="666434"/>
                <a:gridCol w="133287"/>
                <a:gridCol w="492136"/>
                <a:gridCol w="123034"/>
                <a:gridCol w="492136"/>
                <a:gridCol w="112781"/>
                <a:gridCol w="492136"/>
                <a:gridCol w="112781"/>
                <a:gridCol w="492136"/>
                <a:gridCol w="615169"/>
                <a:gridCol w="133287"/>
                <a:gridCol w="492136"/>
                <a:gridCol w="112781"/>
                <a:gridCol w="492136"/>
                <a:gridCol w="133287"/>
                <a:gridCol w="584411"/>
              </a:tblGrid>
              <a:tr h="30143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nimal ID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Time point (Hrs)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PDA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PDB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</a:t>
                      </a:r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PD-B-PPD-A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nimal ID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Time point (Hrs)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PDA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PDB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</a:t>
                      </a:r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PD-B-PPD-A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994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</a:tr>
              <a:tr h="15994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220-5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015-7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0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0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994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2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2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4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5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</a:tr>
              <a:tr h="159944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Difference 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Difference 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994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</a:tr>
              <a:tr h="15994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221-6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017-2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994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2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2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</a:tr>
              <a:tr h="159944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Difference 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2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Difference 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2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994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</a:tr>
              <a:tr h="15994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063-2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058-4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994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2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2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0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</a:tr>
              <a:tr h="159944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Difference 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Difference 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2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994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</a:tr>
              <a:tr h="15994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017-5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010-5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994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2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2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</a:tr>
              <a:tr h="159944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Difference 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Difference 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994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</a:tr>
              <a:tr h="15994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021-2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012-7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0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994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2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2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0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1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</a:tr>
              <a:tr h="159944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Difference 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Difference 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1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994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</a:tr>
              <a:tr h="159944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018-6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994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2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</a:tr>
              <a:tr h="159944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Difference 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994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E9E9"/>
                    </a:solidFill>
                  </a:tcPr>
                </a:tc>
              </a:tr>
              <a:tr h="1660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edian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edian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152" marR="6152" marT="61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1</a:t>
                      </a:r>
                    </a:p>
                  </a:txBody>
                  <a:tcPr marL="6152" marR="6152" marT="61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C0504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780960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54</TotalTime>
  <Words>239</Words>
  <Application>Microsoft Office PowerPoint</Application>
  <PresentationFormat>On-screen Show (4:3)</PresentationFormat>
  <Paragraphs>35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SGU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m Bull</dc:creator>
  <cp:lastModifiedBy>Tim Bull</cp:lastModifiedBy>
  <cp:revision>9</cp:revision>
  <dcterms:created xsi:type="dcterms:W3CDTF">2014-09-04T09:50:27Z</dcterms:created>
  <dcterms:modified xsi:type="dcterms:W3CDTF">2014-10-16T13:43:56Z</dcterms:modified>
</cp:coreProperties>
</file>